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13647E-4884-42F7-B545-4749DD1A7D7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33D829-F514-4FBE-BA7E-42EB91F3D8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9DDDA4-42DC-4901-AE67-431C3E95363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FF432A-1A0D-4F71-942B-F14B43AA5CB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745E42-2416-41B4-95A3-A691915FBD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DDBE9F-5F31-45F6-B48C-EEBF72AC89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A7A4C9-1FDC-4127-B8AD-B82971DB3C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0B60A2-665A-40C4-8143-EFA15E53BD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419C2C-1031-48EB-A5FB-80160A8B3A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75AB5C-2EEA-4FB3-AAED-FF437D7B3B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36193F-3C41-49DF-9DC3-87F2309BD0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A1C6C3-07FD-472C-A2CC-C787E2A3A7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B47AD9-24E1-4F73-9A28-4B44A757A97B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0" y="202680"/>
            <a:ext cx="3186000" cy="5367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CasellaDiTesto 6"/>
          <p:cNvSpPr/>
          <p:nvPr/>
        </p:nvSpPr>
        <p:spPr>
          <a:xfrm>
            <a:off x="714600" y="1407960"/>
            <a:ext cx="2701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Upregulated (194 gene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itle 4"/>
          <p:cNvSpPr/>
          <p:nvPr/>
        </p:nvSpPr>
        <p:spPr>
          <a:xfrm>
            <a:off x="4840200" y="1347840"/>
            <a:ext cx="3956040" cy="46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ownregulated (326 genes)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4"/>
          <p:cNvSpPr/>
          <p:nvPr/>
        </p:nvSpPr>
        <p:spPr>
          <a:xfrm>
            <a:off x="5051520" y="5370480"/>
            <a:ext cx="375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sher test (significance of the overlap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&lt;0.00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4"/>
          <p:cNvSpPr/>
          <p:nvPr/>
        </p:nvSpPr>
        <p:spPr>
          <a:xfrm>
            <a:off x="623880" y="2017800"/>
            <a:ext cx="3855960" cy="2922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17"/>
          <p:cNvSpPr/>
          <p:nvPr/>
        </p:nvSpPr>
        <p:spPr>
          <a:xfrm>
            <a:off x="1743480" y="2087640"/>
            <a:ext cx="1437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Microsoft Sans Serif"/>
              </a:rPr>
              <a:t>Universal list=4337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8"/>
          <p:cNvSpPr/>
          <p:nvPr/>
        </p:nvSpPr>
        <p:spPr>
          <a:xfrm>
            <a:off x="623880" y="4940280"/>
            <a:ext cx="38559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9"/>
          <p:cNvSpPr/>
          <p:nvPr/>
        </p:nvSpPr>
        <p:spPr>
          <a:xfrm>
            <a:off x="623880" y="2017800"/>
            <a:ext cx="1440" cy="2922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Oval 20"/>
          <p:cNvSpPr/>
          <p:nvPr/>
        </p:nvSpPr>
        <p:spPr>
          <a:xfrm>
            <a:off x="944640" y="2260440"/>
            <a:ext cx="1928880" cy="2436840"/>
          </a:xfrm>
          <a:prstGeom prst="ellipse">
            <a:avLst/>
          </a:prstGeom>
          <a:noFill/>
          <a:ln w="0">
            <a:solidFill>
              <a:srgbClr val="1e90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Oval 21"/>
          <p:cNvSpPr/>
          <p:nvPr/>
        </p:nvSpPr>
        <p:spPr>
          <a:xfrm>
            <a:off x="2230560" y="2260440"/>
            <a:ext cx="1928520" cy="2436840"/>
          </a:xfrm>
          <a:prstGeom prst="ellipse">
            <a:avLst/>
          </a:prstGeom>
          <a:noFill/>
          <a:ln w="0">
            <a:solidFill>
              <a:srgbClr val="ff45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22"/>
          <p:cNvSpPr/>
          <p:nvPr/>
        </p:nvSpPr>
        <p:spPr>
          <a:xfrm>
            <a:off x="1847880" y="3392640"/>
            <a:ext cx="215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ahoma"/>
              </a:rPr>
              <a:t>34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23"/>
          <p:cNvSpPr/>
          <p:nvPr/>
        </p:nvSpPr>
        <p:spPr>
          <a:xfrm>
            <a:off x="3132360" y="3392640"/>
            <a:ext cx="215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ahoma"/>
              </a:rPr>
              <a:t>19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24"/>
          <p:cNvSpPr/>
          <p:nvPr/>
        </p:nvSpPr>
        <p:spPr>
          <a:xfrm>
            <a:off x="2490840" y="3392640"/>
            <a:ext cx="215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ahoma"/>
              </a:rPr>
              <a:t>19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26"/>
          <p:cNvSpPr/>
          <p:nvPr/>
        </p:nvSpPr>
        <p:spPr>
          <a:xfrm>
            <a:off x="720720" y="2075040"/>
            <a:ext cx="743040" cy="182880"/>
          </a:xfrm>
          <a:prstGeom prst="rect">
            <a:avLst/>
          </a:prstGeom>
          <a:noFill/>
          <a:ln w="936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ahoma"/>
              </a:rPr>
              <a:t>GEF-R vs 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28"/>
          <p:cNvSpPr/>
          <p:nvPr/>
        </p:nvSpPr>
        <p:spPr>
          <a:xfrm>
            <a:off x="3515040" y="2089080"/>
            <a:ext cx="726120" cy="18288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ahoma"/>
              </a:rPr>
              <a:t>ERL-R vs 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29"/>
          <p:cNvSpPr/>
          <p:nvPr/>
        </p:nvSpPr>
        <p:spPr>
          <a:xfrm>
            <a:off x="623880" y="2017800"/>
            <a:ext cx="3855960" cy="2922480"/>
          </a:xfrm>
          <a:prstGeom prst="rect">
            <a:avLst/>
          </a:pr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36"/>
          <p:cNvSpPr/>
          <p:nvPr/>
        </p:nvSpPr>
        <p:spPr>
          <a:xfrm>
            <a:off x="4888080" y="2011320"/>
            <a:ext cx="3844800" cy="2916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39"/>
          <p:cNvSpPr/>
          <p:nvPr/>
        </p:nvSpPr>
        <p:spPr>
          <a:xfrm>
            <a:off x="6162120" y="2081160"/>
            <a:ext cx="1437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Microsoft Sans Serif"/>
              </a:rPr>
              <a:t>Universal list=4337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40"/>
          <p:cNvSpPr/>
          <p:nvPr/>
        </p:nvSpPr>
        <p:spPr>
          <a:xfrm>
            <a:off x="4888080" y="4927680"/>
            <a:ext cx="38448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41"/>
          <p:cNvSpPr/>
          <p:nvPr/>
        </p:nvSpPr>
        <p:spPr>
          <a:xfrm>
            <a:off x="4888080" y="2011320"/>
            <a:ext cx="1440" cy="29163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Oval 42"/>
          <p:cNvSpPr/>
          <p:nvPr/>
        </p:nvSpPr>
        <p:spPr>
          <a:xfrm>
            <a:off x="5208480" y="2254320"/>
            <a:ext cx="1922400" cy="2428920"/>
          </a:xfrm>
          <a:prstGeom prst="ellipse">
            <a:avLst/>
          </a:prstGeom>
          <a:noFill/>
          <a:ln w="0">
            <a:solidFill>
              <a:srgbClr val="1e90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Oval 43"/>
          <p:cNvSpPr/>
          <p:nvPr/>
        </p:nvSpPr>
        <p:spPr>
          <a:xfrm>
            <a:off x="6489720" y="2254320"/>
            <a:ext cx="1922400" cy="2428920"/>
          </a:xfrm>
          <a:prstGeom prst="ellipse">
            <a:avLst/>
          </a:prstGeom>
          <a:noFill/>
          <a:ln w="0">
            <a:solidFill>
              <a:srgbClr val="ff45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44"/>
          <p:cNvSpPr/>
          <p:nvPr/>
        </p:nvSpPr>
        <p:spPr>
          <a:xfrm>
            <a:off x="6108120" y="3382920"/>
            <a:ext cx="215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ahoma"/>
              </a:rPr>
              <a:t>2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45"/>
          <p:cNvSpPr/>
          <p:nvPr/>
        </p:nvSpPr>
        <p:spPr>
          <a:xfrm>
            <a:off x="7389000" y="3382920"/>
            <a:ext cx="215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ahoma"/>
              </a:rPr>
              <a:t>72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46"/>
          <p:cNvSpPr/>
          <p:nvPr/>
        </p:nvSpPr>
        <p:spPr>
          <a:xfrm>
            <a:off x="6747840" y="3382920"/>
            <a:ext cx="215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ahoma"/>
              </a:rPr>
              <a:t>32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51"/>
          <p:cNvSpPr/>
          <p:nvPr/>
        </p:nvSpPr>
        <p:spPr>
          <a:xfrm>
            <a:off x="4888080" y="2011320"/>
            <a:ext cx="3844800" cy="2916360"/>
          </a:xfrm>
          <a:prstGeom prst="rect">
            <a:avLst/>
          </a:pr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26"/>
          <p:cNvSpPr/>
          <p:nvPr/>
        </p:nvSpPr>
        <p:spPr>
          <a:xfrm>
            <a:off x="4979880" y="2082960"/>
            <a:ext cx="743040" cy="182880"/>
          </a:xfrm>
          <a:prstGeom prst="rect">
            <a:avLst/>
          </a:prstGeom>
          <a:noFill/>
          <a:ln w="9360">
            <a:solidFill>
              <a:srgbClr val="00b0f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ahoma"/>
              </a:rPr>
              <a:t>GEF-R vs 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28"/>
          <p:cNvSpPr/>
          <p:nvPr/>
        </p:nvSpPr>
        <p:spPr>
          <a:xfrm>
            <a:off x="7776000" y="2097000"/>
            <a:ext cx="726120" cy="18288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ahoma"/>
              </a:rPr>
              <a:t>ERL-R vs 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06T09:35:09Z</dcterms:created>
  <dc:creator>Admin</dc:creator>
  <dc:description/>
  <dc:language>en-US</dc:language>
  <cp:lastModifiedBy>Nome utente</cp:lastModifiedBy>
  <dcterms:modified xsi:type="dcterms:W3CDTF">2011-05-23T13:00:04Z</dcterms:modified>
  <cp:revision>246</cp:revision>
  <dc:subject/>
  <dc:title>Diapositiva 1</dc:title>
</cp:coreProperties>
</file>